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48942-BEAA-4093-BF48-CD5D497C4A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0D2E0-0253-4FED-8149-5658C87CF9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83351-FBA1-4533-8925-2EDD2A09DD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7FA5A9-B5FF-4957-97F6-A2081AB415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9616B-A3E5-402D-B760-628221AF59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3AAE4-5881-48E7-9385-9FB520B4BA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1EFA9-0D33-4CA4-B442-731A39C4F8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A7A60-42A8-444B-BBD6-7F2E82C626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AE5772-BAAE-42C6-ABC6-F9F976538E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A8A76-BA84-4950-A31E-F629B86007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9F899-1673-4C03-BEFC-4A16145756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E3C12-2884-42B7-9402-FAC90B14F7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01E3A1-8257-4DCE-8389-FAF565D335B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2"/>
          <p:cNvSpPr/>
          <p:nvPr/>
        </p:nvSpPr>
        <p:spPr>
          <a:xfrm>
            <a:off x="1273320" y="746280"/>
            <a:ext cx="3533400" cy="19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1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GA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CAATGTTTT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2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TGCCAATGTTTT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3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T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CTCCGCGAG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4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TCA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TCCGCGAG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5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TCAA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CGCGAG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6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C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GTTGACCT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7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GCGTTGACCT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8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CGTGATGCTGTG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19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A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TGATGCTGTG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20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ACA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ATGCTGTG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21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G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GCTGTGACG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mu22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T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TGTGACG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3"/>
          <p:cNvSpPr/>
          <p:nvPr/>
        </p:nvSpPr>
        <p:spPr>
          <a:xfrm>
            <a:off x="1272960" y="2798640"/>
            <a:ext cx="4600440" cy="313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5023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AGCAACTACCAGCGC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454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CTATTGTGAGCGCG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3553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ACCACTAACTGACCTTGA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303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TCTAATCATGCTTCTGT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2561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TTGGTATTACTTTGGCTT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2048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TCTCTTACAGATAAAAACTC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1561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TAAACTTGTAGCTTTGC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1048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CCGTCACTCGTTTTATCT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518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CCTACACAGTGCTC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476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AGTTCACTCGCGTTCC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434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ACGCAACCGGCAG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392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GGACTCTCAGTCGG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35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TGAGCCGCAAGGT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308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GGCCGCGGGGA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266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CCGTGTACGTCTGC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224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GCGGCAATGACCT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182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CTCGCTTCGAAGCG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140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GACGAAATTCGTTTG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-97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TTGTATCGCACGAAGA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+85_A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Nco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TG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AT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TCACAAGGGATGAAG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29"/>
          <p:cNvSpPr/>
          <p:nvPr/>
        </p:nvSpPr>
        <p:spPr>
          <a:xfrm>
            <a:off x="1273320" y="6127920"/>
            <a:ext cx="3685680" cy="237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1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CAAGGTCGCGCGA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1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CGCAAGG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2_S2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CGGTGA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AGGTT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3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A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TT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GGCTCAC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3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TCTTCGAACTCTCGG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4_AS2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TT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CTTGCGGCTC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4_S2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AACTCTCGGGAGCTC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5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ACCTTGCGGCTCA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5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ACTCTCGG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6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AACCTTGCGGCTC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6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TCTT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TCGGG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7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AAGACCCGAACCTT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7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T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GCTCGCGG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8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CGAAGACCCGAACCT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-A_mu08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TCG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AAA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CGGG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20"/>
          <p:cNvSpPr/>
          <p:nvPr/>
        </p:nvSpPr>
        <p:spPr>
          <a:xfrm>
            <a:off x="678960" y="566640"/>
            <a:ext cx="583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EcR-B1 promoter mutation constructs (pBmEcR-B1_mu11 to _mu22)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2"/>
          <p:cNvSpPr/>
          <p:nvPr/>
        </p:nvSpPr>
        <p:spPr>
          <a:xfrm>
            <a:off x="321480" y="-4680"/>
            <a:ext cx="2384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ABLE S3.  List of Prim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3"/>
          <p:cNvSpPr/>
          <p:nvPr/>
        </p:nvSpPr>
        <p:spPr>
          <a:xfrm>
            <a:off x="1751040" y="396720"/>
            <a:ext cx="577800" cy="1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a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4"/>
          <p:cNvSpPr/>
          <p:nvPr/>
        </p:nvSpPr>
        <p:spPr>
          <a:xfrm>
            <a:off x="3040200" y="396720"/>
            <a:ext cx="1844640" cy="1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(5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→ 3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5"/>
          <p:cNvSpPr/>
          <p:nvPr/>
        </p:nvSpPr>
        <p:spPr>
          <a:xfrm>
            <a:off x="571680" y="37944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6"/>
          <p:cNvSpPr/>
          <p:nvPr/>
        </p:nvSpPr>
        <p:spPr>
          <a:xfrm>
            <a:off x="571680" y="57960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7"/>
          <p:cNvSpPr/>
          <p:nvPr/>
        </p:nvSpPr>
        <p:spPr>
          <a:xfrm>
            <a:off x="571680" y="851364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6"/>
          <p:cNvSpPr/>
          <p:nvPr/>
        </p:nvSpPr>
        <p:spPr>
          <a:xfrm>
            <a:off x="708480" y="8513640"/>
            <a:ext cx="572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derlined letters indicate restriction sites used for subcloning. Mutagenized nucleotides are bol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7"/>
          <p:cNvSpPr/>
          <p:nvPr/>
        </p:nvSpPr>
        <p:spPr>
          <a:xfrm>
            <a:off x="700920" y="2597040"/>
            <a:ext cx="398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E75-A promoter deletion constructs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20"/>
          <p:cNvSpPr/>
          <p:nvPr/>
        </p:nvSpPr>
        <p:spPr>
          <a:xfrm>
            <a:off x="670320" y="5896080"/>
            <a:ext cx="412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EcR-B1 promoter mutation constructs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9T11:11:12Z</dcterms:created>
  <dc:creator>白井博之</dc:creator>
  <dc:description/>
  <dc:language>en-US</dc:language>
  <cp:lastModifiedBy> </cp:lastModifiedBy>
  <dcterms:modified xsi:type="dcterms:W3CDTF">2012-05-17T06:12:41Z</dcterms:modified>
  <cp:revision>22</cp:revision>
  <dc:subject/>
  <dc:title>スライド 1</dc:title>
</cp:coreProperties>
</file>